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1" r:id="rId2"/>
    <p:sldId id="256" r:id="rId3"/>
    <p:sldId id="257" r:id="rId4"/>
    <p:sldId id="258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725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44E8371-D1B1-4C7D-B3B4-9B5D8119BBD9}" type="datetimeFigureOut">
              <a:rPr lang="zh-CN" altLang="en-US" smtClean="0"/>
              <a:t>2024/4/2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B62920-F459-4398-B629-D034ADA0129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2802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CB62920-F459-4398-B629-D034ADA01293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933760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2365A8C-6F4E-4565-9380-31BB4ECBB6B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E38D310-5FFE-4FD1-B4C9-5D9B646AC03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DA42D1B-1111-4AB8-BD61-7795AA272E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71B6E5-1CED-46DD-82B3-E6C0420B6C57}" type="datetimeFigureOut">
              <a:rPr lang="zh-CN" altLang="en-US" smtClean="0"/>
              <a:t>2024/4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794E477-BF07-4F61-A6A4-A91916C14B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7BD0CFE-9FD3-4BF7-A959-46F613ACB6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69DDF-8E2F-4514-9009-DD951B9227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70353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C6D9764-F5B8-439E-B79F-C7C41F574B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2182024-9F53-481D-B595-D8879D1A417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53A0122-A42E-417F-B769-471671D6E2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71B6E5-1CED-46DD-82B3-E6C0420B6C57}" type="datetimeFigureOut">
              <a:rPr lang="zh-CN" altLang="en-US" smtClean="0"/>
              <a:t>2024/4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E052484-C4B8-4E63-93D9-CDA5DB582C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799AD76-F386-4876-BFA2-3029026F8B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69DDF-8E2F-4514-9009-DD951B9227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03460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75588B52-D830-4FFF-AE80-0CA352C5B69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D46C648-E4BE-45AF-80E0-3BB6D1008E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3FEBAF0-745B-47EA-BD15-F2B2DFFB77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71B6E5-1CED-46DD-82B3-E6C0420B6C57}" type="datetimeFigureOut">
              <a:rPr lang="zh-CN" altLang="en-US" smtClean="0"/>
              <a:t>2024/4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B0A9C6A-CE26-4F2F-92C3-C8AFCEBB97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CCC094E-A1B6-4DC5-BF96-6EEE0B98DF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69DDF-8E2F-4514-9009-DD951B9227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19164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46C1D73-5C46-4E32-AD2F-B6CEB5276D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2F69165-4DBD-4E72-9DB9-ED70A73092F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94F81A7-24CD-486E-9F98-7AA42DC9BC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71B6E5-1CED-46DD-82B3-E6C0420B6C57}" type="datetimeFigureOut">
              <a:rPr lang="zh-CN" altLang="en-US" smtClean="0"/>
              <a:t>2024/4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3D134E6-13C7-4804-805C-641630E1BB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D39BFE9-6664-47B1-8A16-02CEAB28DF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69DDF-8E2F-4514-9009-DD951B9227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35141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BFCF29B-C3D3-4D71-87B2-D69E1C2628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BED1A6C-0E46-4680-8E6F-03CBCF9410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9BF3DA0-82F6-4CA2-9F12-01991E5944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71B6E5-1CED-46DD-82B3-E6C0420B6C57}" type="datetimeFigureOut">
              <a:rPr lang="zh-CN" altLang="en-US" smtClean="0"/>
              <a:t>2024/4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FCFAF87-6D59-4E1C-BBDB-DD72796E75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17AE706-4C50-47C9-8DF0-C1C3ECE66A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69DDF-8E2F-4514-9009-DD951B9227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72366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9F4BA4A-B2B9-471D-AB2F-C3CDB1957B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5AB5024-59AC-4FC2-A9DD-74AECC458CE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F659882-E4A1-480D-9EF2-15182E72181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5B1DF7D-B65C-4D09-8A86-125C372BB4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71B6E5-1CED-46DD-82B3-E6C0420B6C57}" type="datetimeFigureOut">
              <a:rPr lang="zh-CN" altLang="en-US" smtClean="0"/>
              <a:t>2024/4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40985F6-E369-4D34-A9CC-8B8E238F17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CD3A80E-E394-4786-AF54-06902A18AB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69DDF-8E2F-4514-9009-DD951B9227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26500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A14F66D-0546-4F1E-A956-2CB5F61CCF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DF59650-54A5-45FF-BBEF-E28BC9EBC4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97CD1CD-07DD-4D5A-8A09-89863E75B1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865D783B-6F37-44EB-A449-7253BF9DC00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C0559621-0F73-46FA-A046-0654C8A5DB0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FC140E72-9C0E-4EE8-9615-DAF00432DA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71B6E5-1CED-46DD-82B3-E6C0420B6C57}" type="datetimeFigureOut">
              <a:rPr lang="zh-CN" altLang="en-US" smtClean="0"/>
              <a:t>2024/4/2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A485B407-D7C9-4A33-9398-3AB57DE898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444970D2-DAD2-4560-BA0A-839AE89D49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69DDF-8E2F-4514-9009-DD951B9227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36608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C320449-CE38-4D2E-B2BC-B2BAE05D86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998165C7-228A-4CF7-8AD1-3CC98724CE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71B6E5-1CED-46DD-82B3-E6C0420B6C57}" type="datetimeFigureOut">
              <a:rPr lang="zh-CN" altLang="en-US" smtClean="0"/>
              <a:t>2024/4/2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544092D6-36FF-4130-A12F-625638C36F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CE387B2F-9CC1-40A4-B21E-F015E8FD48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69DDF-8E2F-4514-9009-DD951B9227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70636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CFDFD7A-3D80-4B78-BDAA-09EE7B4B4B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71B6E5-1CED-46DD-82B3-E6C0420B6C57}" type="datetimeFigureOut">
              <a:rPr lang="zh-CN" altLang="en-US" smtClean="0"/>
              <a:t>2024/4/2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3627D881-7EAC-4CA5-9C99-699E686EF5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9DFA3B5E-2B8C-45B4-AFA4-9961860D39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69DDF-8E2F-4514-9009-DD951B9227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72611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1E067D1-1605-47D3-B944-18EC4884B3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718A245-B28A-4F49-8CE6-FA68A363E11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684C9F2-AC6B-4499-93A4-4AAC8111E8B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12CA4B5-4DCC-4EB6-95E7-085FFE9BF0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71B6E5-1CED-46DD-82B3-E6C0420B6C57}" type="datetimeFigureOut">
              <a:rPr lang="zh-CN" altLang="en-US" smtClean="0"/>
              <a:t>2024/4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320201A-01D4-4AD3-A952-E65A156161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95620CE-6777-412F-8B25-0885D7DC9B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69DDF-8E2F-4514-9009-DD951B9227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70293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AE14A97-1885-432A-8BCB-575ACF408F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CDD2B36-C378-4F26-9E88-F94AD54C372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3731D40-84FE-43DD-9962-56BE168D39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986DCB8-7FC7-4C5F-8804-798F6DD44C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71B6E5-1CED-46DD-82B3-E6C0420B6C57}" type="datetimeFigureOut">
              <a:rPr lang="zh-CN" altLang="en-US" smtClean="0"/>
              <a:t>2024/4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1CABB97-A968-4233-ADE9-69259924B7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CEFD56C-BC8C-47A1-A27E-A9470849A1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69DDF-8E2F-4514-9009-DD951B9227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39123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2070FFC-4F92-4E45-87F1-7C4F1304A7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D4529A7-E850-43DF-A7A0-CE9C96C4C6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7DDAEF4-350B-40F2-9AD9-B3B6EEFA921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71B6E5-1CED-46DD-82B3-E6C0420B6C57}" type="datetimeFigureOut">
              <a:rPr lang="zh-CN" altLang="en-US" smtClean="0"/>
              <a:t>2024/4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679BBA8-C2FC-4891-8426-2F69953FCE3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EC1BFA0-6FF1-415D-A791-C6A8E58FABE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869DDF-8E2F-4514-9009-DD951B9227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43084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jpg"/><Relationship Id="rId5" Type="http://schemas.openxmlformats.org/officeDocument/2006/relationships/image" Target="../media/image7.jpg"/><Relationship Id="rId4" Type="http://schemas.openxmlformats.org/officeDocument/2006/relationships/image" Target="../media/image6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jpg"/><Relationship Id="rId4" Type="http://schemas.openxmlformats.org/officeDocument/2006/relationships/image" Target="../media/image1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6B12E9B-0B6C-415E-BDA3-7A461E4C4B5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02004" y="1205012"/>
            <a:ext cx="9778738" cy="2387600"/>
          </a:xfrm>
        </p:spPr>
        <p:txBody>
          <a:bodyPr>
            <a:normAutofit/>
          </a:bodyPr>
          <a:lstStyle/>
          <a:p>
            <a:r>
              <a:rPr lang="en-US" altLang="zh-CN" sz="32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 original western blotting  images and the bright field images</a:t>
            </a:r>
            <a:br>
              <a:rPr lang="zh-CN" altLang="zh-CN" sz="4000" kern="100" dirty="0">
                <a:effectLst/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endParaRPr lang="zh-CN" altLang="en-US" dirty="0"/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61826E2C-8D6D-4CA1-8020-52E7CCA2FC2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0643" y="3592612"/>
            <a:ext cx="10501460" cy="1655762"/>
          </a:xfrm>
        </p:spPr>
        <p:txBody>
          <a:bodyPr/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(The western blotting results covered with blue frames were not utilized in this manuscript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506056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8E4C50EC-60B2-459A-8658-F211ADA5AAE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45948" y="3472475"/>
            <a:ext cx="4096512" cy="3340608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3406D595-DE40-4A13-83FE-2C57E25C7F0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0008" y="3472475"/>
            <a:ext cx="4096512" cy="3340608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3BAFE7A9-B706-45B5-B066-CC3683655C2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25181" y="70757"/>
            <a:ext cx="4096512" cy="3340608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5BB93E5C-C738-480B-BC61-F3D5BD9D781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9241" y="70757"/>
            <a:ext cx="4096512" cy="3340608"/>
          </a:xfrm>
          <a:prstGeom prst="rect">
            <a:avLst/>
          </a:prstGeom>
        </p:spPr>
      </p:pic>
      <p:sp>
        <p:nvSpPr>
          <p:cNvPr id="12" name="矩形 11">
            <a:extLst>
              <a:ext uri="{FF2B5EF4-FFF2-40B4-BE49-F238E27FC236}">
                <a16:creationId xmlns:a16="http://schemas.microsoft.com/office/drawing/2014/main" id="{5B1796D3-DA86-45FA-B4A8-B24C6AEC0DFA}"/>
              </a:ext>
            </a:extLst>
          </p:cNvPr>
          <p:cNvSpPr/>
          <p:nvPr/>
        </p:nvSpPr>
        <p:spPr>
          <a:xfrm>
            <a:off x="2886703" y="2056262"/>
            <a:ext cx="546755" cy="160256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E2E88ED2-6C19-4846-B58D-B5D4D27C7BB7}"/>
              </a:ext>
            </a:extLst>
          </p:cNvPr>
          <p:cNvSpPr/>
          <p:nvPr/>
        </p:nvSpPr>
        <p:spPr>
          <a:xfrm>
            <a:off x="3041016" y="4244279"/>
            <a:ext cx="601744" cy="26750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14FE072B-E80B-405A-97EA-B5DE11C18C62}"/>
              </a:ext>
            </a:extLst>
          </p:cNvPr>
          <p:cNvSpPr txBox="1"/>
          <p:nvPr/>
        </p:nvSpPr>
        <p:spPr>
          <a:xfrm>
            <a:off x="1374586" y="4102877"/>
            <a:ext cx="68480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</a:p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5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75FAD7D5-18F2-4DEC-8504-63BF5CA657FA}"/>
              </a:ext>
            </a:extLst>
          </p:cNvPr>
          <p:cNvSpPr txBox="1"/>
          <p:nvPr/>
        </p:nvSpPr>
        <p:spPr>
          <a:xfrm rot="18887063">
            <a:off x="3553255" y="3771715"/>
            <a:ext cx="6687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ker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751A87D6-7890-487E-A620-676B7C64CF69}"/>
              </a:ext>
            </a:extLst>
          </p:cNvPr>
          <p:cNvSpPr txBox="1"/>
          <p:nvPr/>
        </p:nvSpPr>
        <p:spPr>
          <a:xfrm rot="18887063">
            <a:off x="3212031" y="3787074"/>
            <a:ext cx="6944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SCs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C67AA19F-E323-4063-8477-4D4E1C544493}"/>
              </a:ext>
            </a:extLst>
          </p:cNvPr>
          <p:cNvSpPr txBox="1"/>
          <p:nvPr/>
        </p:nvSpPr>
        <p:spPr>
          <a:xfrm rot="18887063">
            <a:off x="2869028" y="3585123"/>
            <a:ext cx="12634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TERT-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SCs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83152DE3-1FEC-44B6-9974-867727449E7C}"/>
              </a:ext>
            </a:extLst>
          </p:cNvPr>
          <p:cNvSpPr txBox="1"/>
          <p:nvPr/>
        </p:nvSpPr>
        <p:spPr>
          <a:xfrm>
            <a:off x="1374586" y="1794652"/>
            <a:ext cx="76655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TERT</a:t>
            </a:r>
          </a:p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7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0C985812-618E-4FB9-98B1-B5E973E839EA}"/>
              </a:ext>
            </a:extLst>
          </p:cNvPr>
          <p:cNvSpPr txBox="1"/>
          <p:nvPr/>
        </p:nvSpPr>
        <p:spPr>
          <a:xfrm rot="18887063">
            <a:off x="3383823" y="1454274"/>
            <a:ext cx="6687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ker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A906CD88-4541-4119-A9F3-51FFF534C816}"/>
              </a:ext>
            </a:extLst>
          </p:cNvPr>
          <p:cNvSpPr txBox="1"/>
          <p:nvPr/>
        </p:nvSpPr>
        <p:spPr>
          <a:xfrm rot="18887063">
            <a:off x="3086248" y="1492473"/>
            <a:ext cx="6944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SCs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C9147D26-4CBA-4DE9-B77C-438A7B325D99}"/>
              </a:ext>
            </a:extLst>
          </p:cNvPr>
          <p:cNvSpPr txBox="1"/>
          <p:nvPr/>
        </p:nvSpPr>
        <p:spPr>
          <a:xfrm rot="18887063">
            <a:off x="2741684" y="1303069"/>
            <a:ext cx="12634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TERT-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SCs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E2C68BA4-FC84-4149-8821-40B7BE758CF4}"/>
              </a:ext>
            </a:extLst>
          </p:cNvPr>
          <p:cNvSpPr/>
          <p:nvPr/>
        </p:nvSpPr>
        <p:spPr>
          <a:xfrm>
            <a:off x="3693926" y="1802171"/>
            <a:ext cx="1414021" cy="65044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 shown in this article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6973F820-35A8-4F93-BA3B-94C888443366}"/>
              </a:ext>
            </a:extLst>
          </p:cNvPr>
          <p:cNvSpPr/>
          <p:nvPr/>
        </p:nvSpPr>
        <p:spPr>
          <a:xfrm>
            <a:off x="3813947" y="4186554"/>
            <a:ext cx="1414021" cy="65044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 shown in this article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id="{940B3610-8763-490E-A683-9B8E190630B4}"/>
              </a:ext>
            </a:extLst>
          </p:cNvPr>
          <p:cNvSpPr/>
          <p:nvPr/>
        </p:nvSpPr>
        <p:spPr>
          <a:xfrm>
            <a:off x="9241383" y="1811165"/>
            <a:ext cx="1414021" cy="65044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 shown in this article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E2C68BA4-FC84-4149-8821-40B7BE758CF4}"/>
              </a:ext>
            </a:extLst>
          </p:cNvPr>
          <p:cNvSpPr/>
          <p:nvPr/>
        </p:nvSpPr>
        <p:spPr>
          <a:xfrm>
            <a:off x="9420738" y="4220682"/>
            <a:ext cx="1414021" cy="65044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 shown in this article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D179DF65-E9CE-47E3-AA82-C8A46AAE4679}"/>
              </a:ext>
            </a:extLst>
          </p:cNvPr>
          <p:cNvSpPr txBox="1"/>
          <p:nvPr/>
        </p:nvSpPr>
        <p:spPr>
          <a:xfrm>
            <a:off x="2021833" y="365285"/>
            <a:ext cx="31749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original image of Figure 2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607158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65905F25-20DC-4BFC-8431-FF5FD96C748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21278" y="0"/>
            <a:ext cx="4096512" cy="3340608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4832D032-EDAB-4BB0-B707-91818E0DDAE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17790" y="0"/>
            <a:ext cx="4096512" cy="3340608"/>
          </a:xfrm>
          <a:prstGeom prst="rect">
            <a:avLst/>
          </a:prstGeom>
        </p:spPr>
      </p:pic>
      <p:sp>
        <p:nvSpPr>
          <p:cNvPr id="8" name="矩形 7">
            <a:extLst>
              <a:ext uri="{FF2B5EF4-FFF2-40B4-BE49-F238E27FC236}">
                <a16:creationId xmlns:a16="http://schemas.microsoft.com/office/drawing/2014/main" id="{0C0A1B93-30E4-41BA-8CC8-CCF5F67EE841}"/>
              </a:ext>
            </a:extLst>
          </p:cNvPr>
          <p:cNvSpPr/>
          <p:nvPr/>
        </p:nvSpPr>
        <p:spPr>
          <a:xfrm>
            <a:off x="4809242" y="1985316"/>
            <a:ext cx="546755" cy="160256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FB0D3D9C-5AC5-4988-A64F-A08479A5B207}"/>
              </a:ext>
            </a:extLst>
          </p:cNvPr>
          <p:cNvSpPr txBox="1"/>
          <p:nvPr/>
        </p:nvSpPr>
        <p:spPr>
          <a:xfrm rot="18887063">
            <a:off x="4431401" y="1510558"/>
            <a:ext cx="6687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ker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62E487D4-2884-4357-8FFA-E6836FCB7139}"/>
              </a:ext>
            </a:extLst>
          </p:cNvPr>
          <p:cNvSpPr txBox="1"/>
          <p:nvPr/>
        </p:nvSpPr>
        <p:spPr>
          <a:xfrm rot="18887063">
            <a:off x="4648480" y="1411343"/>
            <a:ext cx="10631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SCs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EVs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7AB848E7-DAB7-4827-BCA3-88575C2504E0}"/>
              </a:ext>
            </a:extLst>
          </p:cNvPr>
          <p:cNvSpPr txBox="1"/>
          <p:nvPr/>
        </p:nvSpPr>
        <p:spPr>
          <a:xfrm rot="18887063">
            <a:off x="4871328" y="1169960"/>
            <a:ext cx="16321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TERT-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SCs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EVs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7DC7FDF1-1995-4891-959C-A0EE0C3A72D1}"/>
              </a:ext>
            </a:extLst>
          </p:cNvPr>
          <p:cNvSpPr txBox="1"/>
          <p:nvPr/>
        </p:nvSpPr>
        <p:spPr>
          <a:xfrm>
            <a:off x="2129113" y="1802250"/>
            <a:ext cx="67197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IX</a:t>
            </a:r>
          </a:p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6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E2C68BA4-FC84-4149-8821-40B7BE758CF4}"/>
              </a:ext>
            </a:extLst>
          </p:cNvPr>
          <p:cNvSpPr/>
          <p:nvPr/>
        </p:nvSpPr>
        <p:spPr>
          <a:xfrm>
            <a:off x="3137337" y="1740219"/>
            <a:ext cx="1414021" cy="65044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 shown in this article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E2C68BA4-FC84-4149-8821-40B7BE758CF4}"/>
              </a:ext>
            </a:extLst>
          </p:cNvPr>
          <p:cNvSpPr/>
          <p:nvPr/>
        </p:nvSpPr>
        <p:spPr>
          <a:xfrm>
            <a:off x="7274237" y="1820347"/>
            <a:ext cx="1414021" cy="65044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 shown in this article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B87157E8-CE2B-42DD-848A-5662B31F697F}"/>
              </a:ext>
            </a:extLst>
          </p:cNvPr>
          <p:cNvSpPr txBox="1"/>
          <p:nvPr/>
        </p:nvSpPr>
        <p:spPr>
          <a:xfrm>
            <a:off x="2129113" y="599024"/>
            <a:ext cx="31749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original image of Figure 6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id="{6A4B9A8F-CF3A-48A6-BF46-AA0F561530D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21278" y="3372312"/>
            <a:ext cx="4096512" cy="3340608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C1C5AF4E-DF04-4DF7-855A-5C68A4F34EC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17790" y="3372312"/>
            <a:ext cx="4096512" cy="3340608"/>
          </a:xfrm>
          <a:prstGeom prst="rect">
            <a:avLst/>
          </a:prstGeom>
        </p:spPr>
      </p:pic>
      <p:sp>
        <p:nvSpPr>
          <p:cNvPr id="18" name="矩形 17">
            <a:extLst>
              <a:ext uri="{FF2B5EF4-FFF2-40B4-BE49-F238E27FC236}">
                <a16:creationId xmlns:a16="http://schemas.microsoft.com/office/drawing/2014/main" id="{40F4699D-CFAC-4BC9-A487-59D9299D2646}"/>
              </a:ext>
            </a:extLst>
          </p:cNvPr>
          <p:cNvSpPr/>
          <p:nvPr/>
        </p:nvSpPr>
        <p:spPr>
          <a:xfrm>
            <a:off x="4952718" y="4641976"/>
            <a:ext cx="665658" cy="15790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9CF003AC-DC24-4364-8392-574EC1EE99D5}"/>
              </a:ext>
            </a:extLst>
          </p:cNvPr>
          <p:cNvSpPr txBox="1"/>
          <p:nvPr/>
        </p:nvSpPr>
        <p:spPr>
          <a:xfrm rot="18887063">
            <a:off x="4648449" y="4162064"/>
            <a:ext cx="6687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ker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1D492394-94A1-423A-A372-F6ACD556DCD4}"/>
              </a:ext>
            </a:extLst>
          </p:cNvPr>
          <p:cNvSpPr txBox="1"/>
          <p:nvPr/>
        </p:nvSpPr>
        <p:spPr>
          <a:xfrm rot="18887063">
            <a:off x="4796059" y="4068003"/>
            <a:ext cx="10631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SCs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EVs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8F91ED60-01E1-4314-8E84-EC15B3A98AE5}"/>
              </a:ext>
            </a:extLst>
          </p:cNvPr>
          <p:cNvSpPr txBox="1"/>
          <p:nvPr/>
        </p:nvSpPr>
        <p:spPr>
          <a:xfrm rot="18887063">
            <a:off x="5085688" y="3826621"/>
            <a:ext cx="16321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TERT-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SCs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EVs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10DD3828-8FE5-48E6-9555-90FEB04FEC7A}"/>
              </a:ext>
            </a:extLst>
          </p:cNvPr>
          <p:cNvSpPr txBox="1"/>
          <p:nvPr/>
        </p:nvSpPr>
        <p:spPr>
          <a:xfrm>
            <a:off x="2069052" y="4519396"/>
            <a:ext cx="67197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1</a:t>
            </a:r>
          </a:p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5B35FDEC-E28F-4722-B1D5-08D3E5282B81}"/>
              </a:ext>
            </a:extLst>
          </p:cNvPr>
          <p:cNvSpPr/>
          <p:nvPr/>
        </p:nvSpPr>
        <p:spPr>
          <a:xfrm>
            <a:off x="3329988" y="4519396"/>
            <a:ext cx="1414021" cy="65044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 shown in this article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364AF0D5-305E-4D4E-9F9D-701985175CE3}"/>
              </a:ext>
            </a:extLst>
          </p:cNvPr>
          <p:cNvSpPr/>
          <p:nvPr/>
        </p:nvSpPr>
        <p:spPr>
          <a:xfrm>
            <a:off x="7469822" y="4474651"/>
            <a:ext cx="1414021" cy="65044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 shown in this article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431675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图片 17">
            <a:extLst>
              <a:ext uri="{FF2B5EF4-FFF2-40B4-BE49-F238E27FC236}">
                <a16:creationId xmlns:a16="http://schemas.microsoft.com/office/drawing/2014/main" id="{D5FB289D-122D-49C9-A11B-5370BB7BA70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65499" y="115898"/>
            <a:ext cx="4096512" cy="3340608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E1753937-92A8-4E0A-B9C4-23447B1CECF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8987" y="115898"/>
            <a:ext cx="4096512" cy="3340608"/>
          </a:xfrm>
          <a:prstGeom prst="rect">
            <a:avLst/>
          </a:prstGeom>
        </p:spPr>
      </p:pic>
      <p:sp>
        <p:nvSpPr>
          <p:cNvPr id="20" name="矩形 19">
            <a:extLst>
              <a:ext uri="{FF2B5EF4-FFF2-40B4-BE49-F238E27FC236}">
                <a16:creationId xmlns:a16="http://schemas.microsoft.com/office/drawing/2014/main" id="{A27EFE91-2676-42A7-A1D8-BC130F7551BC}"/>
              </a:ext>
            </a:extLst>
          </p:cNvPr>
          <p:cNvSpPr/>
          <p:nvPr/>
        </p:nvSpPr>
        <p:spPr>
          <a:xfrm>
            <a:off x="4670108" y="1394990"/>
            <a:ext cx="580817" cy="15789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FE1D7752-7E69-49B1-9EEB-B0446B734E74}"/>
              </a:ext>
            </a:extLst>
          </p:cNvPr>
          <p:cNvSpPr txBox="1"/>
          <p:nvPr/>
        </p:nvSpPr>
        <p:spPr>
          <a:xfrm rot="18887063">
            <a:off x="4349948" y="918759"/>
            <a:ext cx="6687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ker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DE838635-56D2-4A77-A743-B484974184A4}"/>
              </a:ext>
            </a:extLst>
          </p:cNvPr>
          <p:cNvSpPr txBox="1"/>
          <p:nvPr/>
        </p:nvSpPr>
        <p:spPr>
          <a:xfrm rot="18887063">
            <a:off x="4538867" y="835983"/>
            <a:ext cx="10631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SCs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EVs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E480C1B9-CAF1-4947-8374-607C201B78E1}"/>
              </a:ext>
            </a:extLst>
          </p:cNvPr>
          <p:cNvSpPr txBox="1"/>
          <p:nvPr/>
        </p:nvSpPr>
        <p:spPr>
          <a:xfrm rot="18887063">
            <a:off x="4712037" y="634030"/>
            <a:ext cx="16321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TERT-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SCs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EVs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116">
            <a:extLst>
              <a:ext uri="{FF2B5EF4-FFF2-40B4-BE49-F238E27FC236}">
                <a16:creationId xmlns:a16="http://schemas.microsoft.com/office/drawing/2014/main" id="{8AB4715F-DB10-456B-85DB-77CEE23706CA}"/>
              </a:ext>
            </a:extLst>
          </p:cNvPr>
          <p:cNvSpPr txBox="1"/>
          <p:nvPr/>
        </p:nvSpPr>
        <p:spPr>
          <a:xfrm>
            <a:off x="1627744" y="1262982"/>
            <a:ext cx="79220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SG101</a:t>
            </a:r>
          </a:p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C1D33E22-43B8-445F-9EF6-FC2E78BF1445}"/>
              </a:ext>
            </a:extLst>
          </p:cNvPr>
          <p:cNvSpPr/>
          <p:nvPr/>
        </p:nvSpPr>
        <p:spPr>
          <a:xfrm>
            <a:off x="3052923" y="1262982"/>
            <a:ext cx="1414021" cy="65044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 shown in this article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id="{9690FBFF-EA6A-460A-930C-B03BEC3EBD04}"/>
              </a:ext>
            </a:extLst>
          </p:cNvPr>
          <p:cNvSpPr/>
          <p:nvPr/>
        </p:nvSpPr>
        <p:spPr>
          <a:xfrm>
            <a:off x="7154927" y="1148714"/>
            <a:ext cx="1414021" cy="65044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 shown in this article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7" name="图片 26">
            <a:extLst>
              <a:ext uri="{FF2B5EF4-FFF2-40B4-BE49-F238E27FC236}">
                <a16:creationId xmlns:a16="http://schemas.microsoft.com/office/drawing/2014/main" id="{81A1CBBC-D6F2-4FD1-948F-6C3877B60B6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65499" y="3517392"/>
            <a:ext cx="4096512" cy="3340608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13BE9CFB-3F60-4D0D-BEF2-D51223263C4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8987" y="3517392"/>
            <a:ext cx="4096512" cy="3340608"/>
          </a:xfrm>
          <a:prstGeom prst="rect">
            <a:avLst/>
          </a:prstGeom>
        </p:spPr>
      </p:pic>
      <p:sp>
        <p:nvSpPr>
          <p:cNvPr id="29" name="矩形 28">
            <a:extLst>
              <a:ext uri="{FF2B5EF4-FFF2-40B4-BE49-F238E27FC236}">
                <a16:creationId xmlns:a16="http://schemas.microsoft.com/office/drawing/2014/main" id="{4F01E1EF-4D25-4D57-8979-062AEE88E7E6}"/>
              </a:ext>
            </a:extLst>
          </p:cNvPr>
          <p:cNvSpPr/>
          <p:nvPr/>
        </p:nvSpPr>
        <p:spPr>
          <a:xfrm>
            <a:off x="4834515" y="5091070"/>
            <a:ext cx="546755" cy="160256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8CCCD9B7-FAC9-4D99-A75F-45C4B97DC1A4}"/>
              </a:ext>
            </a:extLst>
          </p:cNvPr>
          <p:cNvSpPr txBox="1"/>
          <p:nvPr/>
        </p:nvSpPr>
        <p:spPr>
          <a:xfrm rot="18887063">
            <a:off x="4459171" y="4630460"/>
            <a:ext cx="6687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ker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BA4D2551-03E8-4EE6-99E2-7ACB66020949}"/>
              </a:ext>
            </a:extLst>
          </p:cNvPr>
          <p:cNvSpPr txBox="1"/>
          <p:nvPr/>
        </p:nvSpPr>
        <p:spPr>
          <a:xfrm rot="18887063">
            <a:off x="4667782" y="4516685"/>
            <a:ext cx="10631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SCs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EVs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C825EB1F-4C73-4547-B8BA-F79951AA2D5C}"/>
              </a:ext>
            </a:extLst>
          </p:cNvPr>
          <p:cNvSpPr txBox="1"/>
          <p:nvPr/>
        </p:nvSpPr>
        <p:spPr>
          <a:xfrm rot="18887063">
            <a:off x="4911740" y="4296927"/>
            <a:ext cx="16321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TERT-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SCs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EVs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FFE12F80-5EFF-44A1-B6AB-C22BC7E7D767}"/>
              </a:ext>
            </a:extLst>
          </p:cNvPr>
          <p:cNvSpPr txBox="1"/>
          <p:nvPr/>
        </p:nvSpPr>
        <p:spPr>
          <a:xfrm>
            <a:off x="1395814" y="4780945"/>
            <a:ext cx="76655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M130</a:t>
            </a:r>
          </a:p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2kD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矩形 33">
            <a:extLst>
              <a:ext uri="{FF2B5EF4-FFF2-40B4-BE49-F238E27FC236}">
                <a16:creationId xmlns:a16="http://schemas.microsoft.com/office/drawing/2014/main" id="{7A94DA8E-279A-4EBE-B915-D083441A1BA3}"/>
              </a:ext>
            </a:extLst>
          </p:cNvPr>
          <p:cNvSpPr/>
          <p:nvPr/>
        </p:nvSpPr>
        <p:spPr>
          <a:xfrm>
            <a:off x="3127221" y="4862471"/>
            <a:ext cx="1414021" cy="65044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 shown in this article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矩形 34">
            <a:extLst>
              <a:ext uri="{FF2B5EF4-FFF2-40B4-BE49-F238E27FC236}">
                <a16:creationId xmlns:a16="http://schemas.microsoft.com/office/drawing/2014/main" id="{278E1990-59A1-4974-ADA7-32BEC3DE1A00}"/>
              </a:ext>
            </a:extLst>
          </p:cNvPr>
          <p:cNvSpPr/>
          <p:nvPr/>
        </p:nvSpPr>
        <p:spPr>
          <a:xfrm>
            <a:off x="7228133" y="4746991"/>
            <a:ext cx="1414021" cy="65044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 shown in this article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F9409E4F-EF3B-46D1-8D94-811E1083C561}"/>
              </a:ext>
            </a:extLst>
          </p:cNvPr>
          <p:cNvSpPr txBox="1"/>
          <p:nvPr/>
        </p:nvSpPr>
        <p:spPr>
          <a:xfrm>
            <a:off x="1452380" y="465780"/>
            <a:ext cx="31749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original image of Figure 6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37139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4</TotalTime>
  <Words>137</Words>
  <Application>Microsoft Office PowerPoint</Application>
  <PresentationFormat>宽屏</PresentationFormat>
  <Paragraphs>48</Paragraphs>
  <Slides>4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0" baseType="lpstr">
      <vt:lpstr>等线</vt:lpstr>
      <vt:lpstr>等线 Light</vt:lpstr>
      <vt:lpstr>Arial</vt:lpstr>
      <vt:lpstr>Calibri</vt:lpstr>
      <vt:lpstr>Times New Roman</vt:lpstr>
      <vt:lpstr>Office 主题​​</vt:lpstr>
      <vt:lpstr>The original western blotting  images and the bright field images 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hpen</dc:creator>
  <cp:lastModifiedBy> </cp:lastModifiedBy>
  <cp:revision>9</cp:revision>
  <dcterms:created xsi:type="dcterms:W3CDTF">2024-04-24T03:01:40Z</dcterms:created>
  <dcterms:modified xsi:type="dcterms:W3CDTF">2024-04-24T07:27:03Z</dcterms:modified>
</cp:coreProperties>
</file>